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7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JT1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43492111111111109</c:v>
                </c:pt>
                <c:pt idx="1">
                  <c:v>5.5555555555555552E-2</c:v>
                </c:pt>
                <c:pt idx="2">
                  <c:v>0.39706222222222221</c:v>
                </c:pt>
                <c:pt idx="3">
                  <c:v>0.21646777777777779</c:v>
                </c:pt>
                <c:pt idx="4">
                  <c:v>0.22251333333333334</c:v>
                </c:pt>
                <c:pt idx="5">
                  <c:v>0.375</c:v>
                </c:pt>
                <c:pt idx="6">
                  <c:v>0.64074111111111109</c:v>
                </c:pt>
                <c:pt idx="7">
                  <c:v>0.61111000000000004</c:v>
                </c:pt>
                <c:pt idx="8">
                  <c:v>0.5</c:v>
                </c:pt>
                <c:pt idx="9">
                  <c:v>0.25925888888888887</c:v>
                </c:pt>
                <c:pt idx="10">
                  <c:v>0.5</c:v>
                </c:pt>
                <c:pt idx="11">
                  <c:v>0</c:v>
                </c:pt>
                <c:pt idx="12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0.51111111111111107</c:v>
                </c:pt>
                <c:pt idx="1">
                  <c:v>0.50555555555555554</c:v>
                </c:pt>
                <c:pt idx="2">
                  <c:v>0.26675555555555558</c:v>
                </c:pt>
                <c:pt idx="3">
                  <c:v>0.25624888888888891</c:v>
                </c:pt>
                <c:pt idx="4">
                  <c:v>0.27538999999999997</c:v>
                </c:pt>
                <c:pt idx="5">
                  <c:v>2.8703333333333334E-2</c:v>
                </c:pt>
                <c:pt idx="6">
                  <c:v>7.0370000000000002E-2</c:v>
                </c:pt>
                <c:pt idx="7">
                  <c:v>0.16666666666666666</c:v>
                </c:pt>
                <c:pt idx="8">
                  <c:v>0</c:v>
                </c:pt>
                <c:pt idx="9">
                  <c:v>0.33333333333333331</c:v>
                </c:pt>
                <c:pt idx="10">
                  <c:v>0.16666666666666666</c:v>
                </c:pt>
                <c:pt idx="11">
                  <c:v>0.25</c:v>
                </c:pt>
                <c:pt idx="12">
                  <c:v>0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2.2222222222222223E-2</c:v>
                </c:pt>
                <c:pt idx="1">
                  <c:v>0.23518555555555556</c:v>
                </c:pt>
                <c:pt idx="2">
                  <c:v>0.24679777777777775</c:v>
                </c:pt>
                <c:pt idx="3">
                  <c:v>0.22350444444444442</c:v>
                </c:pt>
                <c:pt idx="4">
                  <c:v>0.19594111111111112</c:v>
                </c:pt>
                <c:pt idx="5">
                  <c:v>0.10555555555555556</c:v>
                </c:pt>
                <c:pt idx="6">
                  <c:v>0.27777777777777773</c:v>
                </c:pt>
                <c:pt idx="7">
                  <c:v>0.22222333333333333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.75</c:v>
                </c:pt>
                <c:pt idx="12">
                  <c:v>0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3.1745555555555562E-2</c:v>
                </c:pt>
                <c:pt idx="1">
                  <c:v>0.20370333333333335</c:v>
                </c:pt>
                <c:pt idx="2">
                  <c:v>8.9384444444444447E-2</c:v>
                </c:pt>
                <c:pt idx="3">
                  <c:v>0.30377999999999999</c:v>
                </c:pt>
                <c:pt idx="4">
                  <c:v>0.30615555555555557</c:v>
                </c:pt>
                <c:pt idx="5">
                  <c:v>0.49074111111111107</c:v>
                </c:pt>
                <c:pt idx="6">
                  <c:v>1.1111111111111112E-2</c:v>
                </c:pt>
                <c:pt idx="7">
                  <c:v>0</c:v>
                </c:pt>
                <c:pt idx="8">
                  <c:v>0.5</c:v>
                </c:pt>
                <c:pt idx="9">
                  <c:v>0.40740777777777781</c:v>
                </c:pt>
                <c:pt idx="10">
                  <c:v>0.33333333333333331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0946544"/>
        <c:axId val="190945984"/>
      </c:barChart>
      <c:valAx>
        <c:axId val="190945984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97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5’ Base</a:t>
                </a:r>
                <a:r>
                  <a:rPr lang="en-US" baseline="0" dirty="0" smtClean="0"/>
                  <a:t> dominance </a:t>
                </a:r>
                <a:r>
                  <a:rPr lang="en-US" dirty="0" smtClean="0"/>
                  <a:t>Percentage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97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0946544"/>
        <c:crosses val="autoZero"/>
        <c:crossBetween val="between"/>
      </c:valAx>
      <c:catAx>
        <c:axId val="19094654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Nucleotide size distribution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97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094598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JT4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33333333333333331</c:v>
                </c:pt>
                <c:pt idx="1">
                  <c:v>0.33333499999999999</c:v>
                </c:pt>
                <c:pt idx="2">
                  <c:v>0.48412499999999997</c:v>
                </c:pt>
                <c:pt idx="3">
                  <c:v>0.32048888888888888</c:v>
                </c:pt>
                <c:pt idx="4">
                  <c:v>0.3156566666666667</c:v>
                </c:pt>
                <c:pt idx="5">
                  <c:v>0.6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0.16666666666666666</c:v>
                </c:pt>
                <c:pt idx="1">
                  <c:v>0.66666500000000006</c:v>
                </c:pt>
                <c:pt idx="2">
                  <c:v>0.17777833333333334</c:v>
                </c:pt>
                <c:pt idx="3">
                  <c:v>0.34209111111111112</c:v>
                </c:pt>
                <c:pt idx="4">
                  <c:v>4.7618333333333339E-2</c:v>
                </c:pt>
                <c:pt idx="5">
                  <c:v>0.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16666666666666666</c:v>
                </c:pt>
                <c:pt idx="1">
                  <c:v>0</c:v>
                </c:pt>
                <c:pt idx="2">
                  <c:v>0.25714333333333333</c:v>
                </c:pt>
                <c:pt idx="3">
                  <c:v>6.5403333333333327E-2</c:v>
                </c:pt>
                <c:pt idx="4">
                  <c:v>0.52994333333333332</c:v>
                </c:pt>
                <c:pt idx="5">
                  <c:v>0.1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3333333333333331</c:v>
                </c:pt>
                <c:pt idx="1">
                  <c:v>0</c:v>
                </c:pt>
                <c:pt idx="2">
                  <c:v>8.0953333333333335E-2</c:v>
                </c:pt>
                <c:pt idx="3">
                  <c:v>0.27201777777777775</c:v>
                </c:pt>
                <c:pt idx="4">
                  <c:v>0.10678333333333333</c:v>
                </c:pt>
                <c:pt idx="5">
                  <c:v>0.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1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235982400"/>
        <c:axId val="235981840"/>
      </c:barChart>
      <c:valAx>
        <c:axId val="235981840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5982400"/>
        <c:crosses val="autoZero"/>
        <c:crossBetween val="between"/>
      </c:valAx>
      <c:catAx>
        <c:axId val="23598240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598184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QT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3833333333333333</c:v>
                </c:pt>
                <c:pt idx="1">
                  <c:v>0.11944444444444442</c:v>
                </c:pt>
                <c:pt idx="2">
                  <c:v>0.27786555555555559</c:v>
                </c:pt>
                <c:pt idx="3">
                  <c:v>0.28951777777777782</c:v>
                </c:pt>
                <c:pt idx="4">
                  <c:v>0.21829444444444443</c:v>
                </c:pt>
                <c:pt idx="5">
                  <c:v>0.18756666666666666</c:v>
                </c:pt>
                <c:pt idx="6">
                  <c:v>0.16666666666666666</c:v>
                </c:pt>
                <c:pt idx="7">
                  <c:v>0</c:v>
                </c:pt>
                <c:pt idx="8">
                  <c:v>0.33333333333333331</c:v>
                </c:pt>
                <c:pt idx="9">
                  <c:v>0</c:v>
                </c:pt>
                <c:pt idx="10">
                  <c:v>0.625</c:v>
                </c:pt>
                <c:pt idx="11">
                  <c:v>0.44444499999999998</c:v>
                </c:pt>
                <c:pt idx="12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9.9999999999999992E-2</c:v>
                </c:pt>
                <c:pt idx="1">
                  <c:v>0.27499999999999997</c:v>
                </c:pt>
                <c:pt idx="2">
                  <c:v>0.22519111111111109</c:v>
                </c:pt>
                <c:pt idx="3">
                  <c:v>0.32925999999999994</c:v>
                </c:pt>
                <c:pt idx="4">
                  <c:v>0.30602333333333337</c:v>
                </c:pt>
                <c:pt idx="5">
                  <c:v>7.8306666666666663E-2</c:v>
                </c:pt>
                <c:pt idx="6">
                  <c:v>0.72222222222222221</c:v>
                </c:pt>
                <c:pt idx="7">
                  <c:v>0.5</c:v>
                </c:pt>
                <c:pt idx="8">
                  <c:v>0.16666666666666666</c:v>
                </c:pt>
                <c:pt idx="9">
                  <c:v>0.33333333333333331</c:v>
                </c:pt>
                <c:pt idx="10">
                  <c:v>0.125</c:v>
                </c:pt>
                <c:pt idx="11">
                  <c:v>0.16666666666666666</c:v>
                </c:pt>
                <c:pt idx="12">
                  <c:v>0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44444444444444442</c:v>
                </c:pt>
                <c:pt idx="1">
                  <c:v>0.34722222222222227</c:v>
                </c:pt>
                <c:pt idx="2">
                  <c:v>0.21363999999999997</c:v>
                </c:pt>
                <c:pt idx="3">
                  <c:v>0.21136999999999997</c:v>
                </c:pt>
                <c:pt idx="4">
                  <c:v>0.28037333333333331</c:v>
                </c:pt>
                <c:pt idx="5">
                  <c:v>0.22645555555555555</c:v>
                </c:pt>
                <c:pt idx="6">
                  <c:v>0.1111111111111111</c:v>
                </c:pt>
                <c:pt idx="7">
                  <c:v>0</c:v>
                </c:pt>
                <c:pt idx="8">
                  <c:v>0.33333333333333331</c:v>
                </c:pt>
                <c:pt idx="9">
                  <c:v>0.16666666666666666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7.2222222222222229E-2</c:v>
                </c:pt>
                <c:pt idx="1">
                  <c:v>0.2583333333333333</c:v>
                </c:pt>
                <c:pt idx="2">
                  <c:v>0.2833033333333333</c:v>
                </c:pt>
                <c:pt idx="3">
                  <c:v>0.16985333333333333</c:v>
                </c:pt>
                <c:pt idx="4">
                  <c:v>0.19530777777777777</c:v>
                </c:pt>
                <c:pt idx="5">
                  <c:v>0.50767111111111107</c:v>
                </c:pt>
                <c:pt idx="6">
                  <c:v>0</c:v>
                </c:pt>
                <c:pt idx="7">
                  <c:v>0.5</c:v>
                </c:pt>
                <c:pt idx="8">
                  <c:v>0.16666666666666666</c:v>
                </c:pt>
                <c:pt idx="9">
                  <c:v>0.5</c:v>
                </c:pt>
                <c:pt idx="10">
                  <c:v>0.25</c:v>
                </c:pt>
                <c:pt idx="11">
                  <c:v>0.38888833333333334</c:v>
                </c:pt>
                <c:pt idx="1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241842400"/>
        <c:axId val="241841840"/>
      </c:barChart>
      <c:valAx>
        <c:axId val="241841840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1842400"/>
        <c:crosses val="autoZero"/>
        <c:crossBetween val="between"/>
      </c:valAx>
      <c:catAx>
        <c:axId val="24184240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184184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QT4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33333333333333331</c:v>
                </c:pt>
                <c:pt idx="1">
                  <c:v>0.75</c:v>
                </c:pt>
                <c:pt idx="2">
                  <c:v>0.43304833333333342</c:v>
                </c:pt>
                <c:pt idx="3">
                  <c:v>0.46212166666666671</c:v>
                </c:pt>
                <c:pt idx="4">
                  <c:v>0.1991111111111111</c:v>
                </c:pt>
                <c:pt idx="5">
                  <c:v>0.1666650000000000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1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0.16666666666666666</c:v>
                </c:pt>
                <c:pt idx="1">
                  <c:v>0</c:v>
                </c:pt>
                <c:pt idx="2">
                  <c:v>5.1282222222222222E-2</c:v>
                </c:pt>
                <c:pt idx="3">
                  <c:v>0.20530166666666669</c:v>
                </c:pt>
                <c:pt idx="4">
                  <c:v>0.332851111111111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</c:v>
                </c:pt>
                <c:pt idx="1">
                  <c:v>0.25</c:v>
                </c:pt>
                <c:pt idx="2">
                  <c:v>0.38746444444444444</c:v>
                </c:pt>
                <c:pt idx="3">
                  <c:v>0.24507500000000002</c:v>
                </c:pt>
                <c:pt idx="4">
                  <c:v>0.32961777777777779</c:v>
                </c:pt>
                <c:pt idx="5">
                  <c:v>0.33333499999999999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5</c:v>
                </c:pt>
                <c:pt idx="1">
                  <c:v>0</c:v>
                </c:pt>
                <c:pt idx="2">
                  <c:v>0.1282061111111111</c:v>
                </c:pt>
                <c:pt idx="3">
                  <c:v>8.7500000000000008E-2</c:v>
                </c:pt>
                <c:pt idx="4">
                  <c:v>0.1384188888888889</c:v>
                </c:pt>
                <c:pt idx="5">
                  <c:v>0.5</c:v>
                </c:pt>
                <c:pt idx="6">
                  <c:v>0</c:v>
                </c:pt>
                <c:pt idx="7">
                  <c:v>1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237724656"/>
        <c:axId val="237724096"/>
      </c:barChart>
      <c:valAx>
        <c:axId val="237724096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7724656"/>
        <c:crosses val="autoZero"/>
        <c:crossBetween val="between"/>
      </c:valAx>
      <c:catAx>
        <c:axId val="23772465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772409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RT1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7381</c:v>
                </c:pt>
                <c:pt idx="1">
                  <c:v>0.14351888888888889</c:v>
                </c:pt>
                <c:pt idx="2">
                  <c:v>0.22767999999999999</c:v>
                </c:pt>
                <c:pt idx="3">
                  <c:v>0.20094444444444448</c:v>
                </c:pt>
                <c:pt idx="4">
                  <c:v>0.18130222222222223</c:v>
                </c:pt>
                <c:pt idx="5">
                  <c:v>0.46467222222222221</c:v>
                </c:pt>
                <c:pt idx="6">
                  <c:v>0.30599666666666669</c:v>
                </c:pt>
                <c:pt idx="7">
                  <c:v>0.23333333333333331</c:v>
                </c:pt>
                <c:pt idx="8">
                  <c:v>0.22222166666666668</c:v>
                </c:pt>
                <c:pt idx="9">
                  <c:v>0</c:v>
                </c:pt>
                <c:pt idx="10">
                  <c:v>3.3333333333333333E-2</c:v>
                </c:pt>
                <c:pt idx="11">
                  <c:v>0</c:v>
                </c:pt>
                <c:pt idx="12">
                  <c:v>0.25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6.6666666666666666E-2</c:v>
                </c:pt>
                <c:pt idx="1">
                  <c:v>0.34722222222222227</c:v>
                </c:pt>
                <c:pt idx="2">
                  <c:v>0.47120777777777773</c:v>
                </c:pt>
                <c:pt idx="3">
                  <c:v>0.38117000000000001</c:v>
                </c:pt>
                <c:pt idx="4">
                  <c:v>0.21166666666666667</c:v>
                </c:pt>
                <c:pt idx="5">
                  <c:v>0.20156666666666667</c:v>
                </c:pt>
                <c:pt idx="6">
                  <c:v>0.24779444444444446</c:v>
                </c:pt>
                <c:pt idx="7">
                  <c:v>0.41111111111111115</c:v>
                </c:pt>
                <c:pt idx="8">
                  <c:v>0.69444499999999998</c:v>
                </c:pt>
                <c:pt idx="9">
                  <c:v>0</c:v>
                </c:pt>
                <c:pt idx="10">
                  <c:v>0.81666666666666676</c:v>
                </c:pt>
                <c:pt idx="11">
                  <c:v>0.5</c:v>
                </c:pt>
                <c:pt idx="12">
                  <c:v>0.25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15476166666666666</c:v>
                </c:pt>
                <c:pt idx="1">
                  <c:v>0.125</c:v>
                </c:pt>
                <c:pt idx="2">
                  <c:v>0.13691444444444445</c:v>
                </c:pt>
                <c:pt idx="3">
                  <c:v>0.22196888888888888</c:v>
                </c:pt>
                <c:pt idx="4">
                  <c:v>0.21070222222222221</c:v>
                </c:pt>
                <c:pt idx="5">
                  <c:v>0.16709444444444443</c:v>
                </c:pt>
                <c:pt idx="6">
                  <c:v>0.10052888888888889</c:v>
                </c:pt>
                <c:pt idx="7">
                  <c:v>0.18888888888888888</c:v>
                </c:pt>
                <c:pt idx="8">
                  <c:v>8.3333333333333329E-2</c:v>
                </c:pt>
                <c:pt idx="9">
                  <c:v>0.25</c:v>
                </c:pt>
                <c:pt idx="10">
                  <c:v>3.3333333333333333E-2</c:v>
                </c:pt>
                <c:pt idx="11">
                  <c:v>0</c:v>
                </c:pt>
                <c:pt idx="12">
                  <c:v>0.375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50476166666666666</c:v>
                </c:pt>
                <c:pt idx="1">
                  <c:v>0.38425888888888887</c:v>
                </c:pt>
                <c:pt idx="2">
                  <c:v>0.16419555555555557</c:v>
                </c:pt>
                <c:pt idx="3">
                  <c:v>0.19591666666666666</c:v>
                </c:pt>
                <c:pt idx="4">
                  <c:v>0.39632777777777778</c:v>
                </c:pt>
                <c:pt idx="5">
                  <c:v>0.16666666666666666</c:v>
                </c:pt>
                <c:pt idx="6">
                  <c:v>0.34567888888888887</c:v>
                </c:pt>
                <c:pt idx="7">
                  <c:v>0.16666666666666666</c:v>
                </c:pt>
                <c:pt idx="8">
                  <c:v>0</c:v>
                </c:pt>
                <c:pt idx="9">
                  <c:v>0.75</c:v>
                </c:pt>
                <c:pt idx="10">
                  <c:v>0.11666666666666665</c:v>
                </c:pt>
                <c:pt idx="11">
                  <c:v>0.5</c:v>
                </c:pt>
                <c:pt idx="12">
                  <c:v>0.1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242958592"/>
        <c:axId val="242958032"/>
      </c:barChart>
      <c:valAx>
        <c:axId val="242958032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2958592"/>
        <c:crosses val="autoZero"/>
        <c:crossBetween val="between"/>
      </c:valAx>
      <c:catAx>
        <c:axId val="2429585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295803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RT4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3077</c:v>
                </c:pt>
                <c:pt idx="1">
                  <c:v>0.35714166666666669</c:v>
                </c:pt>
                <c:pt idx="2">
                  <c:v>0.28807444444444447</c:v>
                </c:pt>
                <c:pt idx="3">
                  <c:v>0.26218999999999998</c:v>
                </c:pt>
                <c:pt idx="4">
                  <c:v>0.19912944444444444</c:v>
                </c:pt>
                <c:pt idx="5">
                  <c:v>1.5554999999999999E-2</c:v>
                </c:pt>
                <c:pt idx="6">
                  <c:v>0.253245</c:v>
                </c:pt>
                <c:pt idx="7">
                  <c:v>7.1429999999999993E-2</c:v>
                </c:pt>
                <c:pt idx="8">
                  <c:v>6.6666666666666666E-2</c:v>
                </c:pt>
                <c:pt idx="9">
                  <c:v>0.14444333333333334</c:v>
                </c:pt>
                <c:pt idx="10">
                  <c:v>0.375</c:v>
                </c:pt>
                <c:pt idx="11">
                  <c:v>0.52777666666666667</c:v>
                </c:pt>
                <c:pt idx="12">
                  <c:v>0.16666666666666666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0</c:v>
                </c:pt>
                <c:pt idx="1">
                  <c:v>0.27380833333333338</c:v>
                </c:pt>
                <c:pt idx="2">
                  <c:v>0.20622777777777776</c:v>
                </c:pt>
                <c:pt idx="3">
                  <c:v>0.40047444444444441</c:v>
                </c:pt>
                <c:pt idx="4">
                  <c:v>0.20864777777777777</c:v>
                </c:pt>
                <c:pt idx="5">
                  <c:v>0.34</c:v>
                </c:pt>
                <c:pt idx="6">
                  <c:v>0.16450499999999998</c:v>
                </c:pt>
                <c:pt idx="7">
                  <c:v>0.39285500000000001</c:v>
                </c:pt>
                <c:pt idx="8">
                  <c:v>0.73333333333333339</c:v>
                </c:pt>
                <c:pt idx="9">
                  <c:v>0.70555666666666672</c:v>
                </c:pt>
                <c:pt idx="10">
                  <c:v>4.1667500000000003E-2</c:v>
                </c:pt>
                <c:pt idx="11">
                  <c:v>0.19444333333333333</c:v>
                </c:pt>
                <c:pt idx="12">
                  <c:v>0.66666666666666663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51922999999999997</c:v>
                </c:pt>
                <c:pt idx="1">
                  <c:v>0.27976333333333331</c:v>
                </c:pt>
                <c:pt idx="2">
                  <c:v>0.32511222222222219</c:v>
                </c:pt>
                <c:pt idx="3">
                  <c:v>0.19281222222222219</c:v>
                </c:pt>
                <c:pt idx="4">
                  <c:v>0.18803888888888889</c:v>
                </c:pt>
                <c:pt idx="5">
                  <c:v>0.38000000000000006</c:v>
                </c:pt>
                <c:pt idx="6">
                  <c:v>0.218615</c:v>
                </c:pt>
                <c:pt idx="7">
                  <c:v>0.285715</c:v>
                </c:pt>
                <c:pt idx="8">
                  <c:v>0.13333333333333333</c:v>
                </c:pt>
                <c:pt idx="9">
                  <c:v>8.3333333333333329E-2</c:v>
                </c:pt>
                <c:pt idx="10">
                  <c:v>0.5</c:v>
                </c:pt>
                <c:pt idx="11">
                  <c:v>0.16666666666666666</c:v>
                </c:pt>
                <c:pt idx="12">
                  <c:v>0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25</c:v>
                </c:pt>
                <c:pt idx="1">
                  <c:v>8.9285000000000003E-2</c:v>
                </c:pt>
                <c:pt idx="2">
                  <c:v>0.18058666666666667</c:v>
                </c:pt>
                <c:pt idx="3">
                  <c:v>0.14452333333333334</c:v>
                </c:pt>
                <c:pt idx="4">
                  <c:v>0.4041838888888889</c:v>
                </c:pt>
                <c:pt idx="5">
                  <c:v>0.26444499999999999</c:v>
                </c:pt>
                <c:pt idx="6">
                  <c:v>0.36363666666666666</c:v>
                </c:pt>
                <c:pt idx="7">
                  <c:v>0.25</c:v>
                </c:pt>
                <c:pt idx="8">
                  <c:v>6.6666666666666666E-2</c:v>
                </c:pt>
                <c:pt idx="9">
                  <c:v>6.6666666666666666E-2</c:v>
                </c:pt>
                <c:pt idx="10">
                  <c:v>8.3332500000000004E-2</c:v>
                </c:pt>
                <c:pt idx="11">
                  <c:v>0.11111</c:v>
                </c:pt>
                <c:pt idx="12">
                  <c:v>0.166666666666666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242963072"/>
        <c:axId val="242962512"/>
      </c:barChart>
      <c:valAx>
        <c:axId val="242962512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2963072"/>
        <c:crosses val="autoZero"/>
        <c:crossBetween val="between"/>
      </c:valAx>
      <c:catAx>
        <c:axId val="24296307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296251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3676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546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569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796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540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598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847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8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068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968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633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021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526386341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172938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154554842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8944619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766608391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3350826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168618505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9048832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272361224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8303789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525846634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990958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7</TotalTime>
  <Words>14</Words>
  <Application>Microsoft Office PowerPoint</Application>
  <PresentationFormat>Widescreen</PresentationFormat>
  <Paragraphs>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S</dc:creator>
  <cp:lastModifiedBy>NS</cp:lastModifiedBy>
  <cp:revision>17</cp:revision>
  <dcterms:created xsi:type="dcterms:W3CDTF">2019-03-23T18:15:24Z</dcterms:created>
  <dcterms:modified xsi:type="dcterms:W3CDTF">2019-03-24T06:59:55Z</dcterms:modified>
</cp:coreProperties>
</file>